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9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4995" autoAdjust="0"/>
    <p:restoredTop sz="94660"/>
  </p:normalViewPr>
  <p:slideViewPr>
    <p:cSldViewPr snapToGrid="0">
      <p:cViewPr varScale="1">
        <p:scale>
          <a:sx n="86" d="100"/>
          <a:sy n="86" d="100"/>
        </p:scale>
        <p:origin x="562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12233D3-C38A-4E4E-894A-40D91F5B2120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8494FA47-6A9D-485E-A279-4577181F2568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98E6D63-C728-4B88-9D7D-A492F16369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069CA-2B2E-4F97-8D77-29F9BD4CF3D1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84392EA-AA73-4919-905B-A188A144069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39EF45F-BC9B-4F5C-BABA-84353C1CC2C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592E3-CE4B-40F8-A10A-3B67573D5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300494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8C6044B-8440-4516-AE97-A4CC66A1E559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E0A8FE48-0722-4322-8F80-37F706FA8EEE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1972A18-92DA-4A98-9DDF-73FB15F48C9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069CA-2B2E-4F97-8D77-29F9BD4CF3D1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C3E1A4AE-B9DA-4D9D-8AB4-25A18D59F1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975F719-27D4-4E06-BF48-B1133E58FE2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592E3-CE4B-40F8-A10A-3B67573D5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32909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F92D06E7-AB2E-42CF-A261-CE11E808DBCF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4B3C108F-1EA5-4752-993A-FBA4FD770381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1E029FF-43BA-4FEE-9683-D6F61FB7195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069CA-2B2E-4F97-8D77-29F9BD4CF3D1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277D2232-8DAD-4708-ABB9-14097BA60FA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8D46C2C5-8F34-4D6A-9C90-7BA1B43F053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592E3-CE4B-40F8-A10A-3B67573D5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5391200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005C151-F839-473F-A244-B82BBD496E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3D14C3-06CA-433B-B788-F54798D32AC9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264B558-C0BC-4EF9-98CC-F2BD5512FDE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069CA-2B2E-4F97-8D77-29F9BD4CF3D1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7FFC90E-43E1-495C-855B-442AB707753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01B917D-B421-405B-8579-C3D27CDE8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592E3-CE4B-40F8-A10A-3B67573D5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7243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22D1CC-1110-4444-B87B-C95B00CFA8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4B67F903-8A60-44D0-B91A-3F769FD03D0C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A45215E-D2F3-4EC0-8FA0-E16C806853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069CA-2B2E-4F97-8D77-29F9BD4CF3D1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E7D11C2-015A-4324-A609-7EEA8FCD89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B823AD9A-4001-4912-8C9E-77E30B1A01E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592E3-CE4B-40F8-A10A-3B67573D5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315203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B542F41-2676-4DC8-AFAC-C11A82ECDC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90745D-3268-46B0-8AE0-F08A33FAB35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84FB6BA1-BA94-4B4E-A811-F1BDF01AA1A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66F5ED21-13AC-4BDE-B505-AC5D930183D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069CA-2B2E-4F97-8D77-29F9BD4CF3D1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52C6373-EC21-482A-8B5F-5EA1C6B1E2D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EA7A8CE-2EC0-4480-B37C-48F88719F0A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592E3-CE4B-40F8-A10A-3B67573D5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785334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7FAC5C-7CED-4C07-A3D2-2C7EF427B72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90B6BD67-2418-4EDD-9F84-9FF39B208F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A5D0F6-9166-4CA6-BECE-070F2918090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9D8B26DD-DA8C-4979-90D2-808656D18FA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5100E35-3D3F-4ED3-9F48-29E813EF32A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9376C9F6-1206-46C4-96AD-5C12A09507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069CA-2B2E-4F97-8D77-29F9BD4CF3D1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825CACDE-8985-4E91-A191-5181AE58D47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D991BE5A-319D-4B37-A1BA-36ACF89478E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592E3-CE4B-40F8-A10A-3B67573D5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8236533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62C8D22-F0C8-4A93-B8D0-F34849444E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800AD47-DEBA-41C1-8EA1-1B1F6453290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069CA-2B2E-4F97-8D77-29F9BD4CF3D1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4189A329-0485-46F3-AD41-4BC0E35F33B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7B23FCF8-4255-4916-B298-ACDD3D79539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592E3-CE4B-40F8-A10A-3B67573D5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273107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74D0834F-E57E-4167-A9C9-F4E41BD11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069CA-2B2E-4F97-8D77-29F9BD4CF3D1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6F2D1092-EFCE-42C9-91DB-C2010F85B5C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71407E60-027F-4402-A59F-7A9FC61D332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592E3-CE4B-40F8-A10A-3B67573D5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807927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D37C539-D487-4346-8303-FB5D48D516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E3816EE-C37D-47E0-9AE3-3C7CF6559A6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D5C705A-8BC0-41A4-B79C-52F1CA22EC91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A7492EF6-F2A5-4293-8F8A-C443C0D9954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069CA-2B2E-4F97-8D77-29F9BD4CF3D1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77E48678-20E8-4FD6-A9E8-E3D8901A0C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226C88CE-97D4-489F-ACA5-74037E393EA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592E3-CE4B-40F8-A10A-3B67573D5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7339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8684C09-58A8-4F5A-B449-09C88AE422F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57BC2EAB-E596-4AF4-9450-9308DA661979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9EA29CA-28B9-4095-A8CB-F8A8D62C8F5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6F56967-EA5B-46B6-8C55-0B08A8295C3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D88069CA-2B2E-4F97-8D77-29F9BD4CF3D1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A3F20546-7876-42A1-B0EE-FF1015AA30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29AA7D1-42F5-4FEF-851E-FE4C37742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F592E3-CE4B-40F8-A10A-3B67573D5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579243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D72ECC8-4412-4F57-B2C3-DC7C036E8D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06046DF1-4D8B-4678-93FB-8383316CE8A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0E2EAE8-68C7-4643-8B23-14889B2FA521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88069CA-2B2E-4F97-8D77-29F9BD4CF3D1}" type="datetimeFigureOut">
              <a:rPr lang="en-US" smtClean="0"/>
              <a:t>1/13/20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7077339-D5F4-4667-83D1-0701035235E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BCDCEDA-B588-4764-9738-AF6765117484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F592E3-CE4B-40F8-A10A-3B67573D52EB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3792292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4E3B8D6B-D216-4C55-ABA6-8A066E955C6F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4013" t="10745" r="71230" b="58964"/>
          <a:stretch/>
        </p:blipFill>
        <p:spPr>
          <a:xfrm>
            <a:off x="276244" y="692458"/>
            <a:ext cx="1847808" cy="1695635"/>
          </a:xfrm>
          <a:prstGeom prst="rect">
            <a:avLst/>
          </a:prstGeom>
        </p:spPr>
      </p:pic>
      <p:pic>
        <p:nvPicPr>
          <p:cNvPr id="3" name="Picture 2">
            <a:extLst>
              <a:ext uri="{FF2B5EF4-FFF2-40B4-BE49-F238E27FC236}">
                <a16:creationId xmlns:a16="http://schemas.microsoft.com/office/drawing/2014/main" id="{2828F313-9849-4BE8-93E7-7BDA8CB5AAC2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867" t="11780" r="35793" b="55858"/>
          <a:stretch/>
        </p:blipFill>
        <p:spPr>
          <a:xfrm>
            <a:off x="2211007" y="692457"/>
            <a:ext cx="1770244" cy="1695635"/>
          </a:xfrm>
          <a:prstGeom prst="rect">
            <a:avLst/>
          </a:prstGeom>
        </p:spPr>
      </p:pic>
      <p:pic>
        <p:nvPicPr>
          <p:cNvPr id="4" name="Picture 3">
            <a:extLst>
              <a:ext uri="{FF2B5EF4-FFF2-40B4-BE49-F238E27FC236}">
                <a16:creationId xmlns:a16="http://schemas.microsoft.com/office/drawing/2014/main" id="{9398E49A-AC74-41A5-B697-25C34B0EE9D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4208" t="10227" r="2200" b="60388"/>
          <a:stretch/>
        </p:blipFill>
        <p:spPr>
          <a:xfrm>
            <a:off x="4068205" y="692457"/>
            <a:ext cx="1925417" cy="1695635"/>
          </a:xfrm>
          <a:prstGeom prst="rect">
            <a:avLst/>
          </a:prstGeom>
        </p:spPr>
      </p:pic>
      <p:pic>
        <p:nvPicPr>
          <p:cNvPr id="5" name="Picture 4">
            <a:extLst>
              <a:ext uri="{FF2B5EF4-FFF2-40B4-BE49-F238E27FC236}">
                <a16:creationId xmlns:a16="http://schemas.microsoft.com/office/drawing/2014/main" id="{9BE39949-5B76-4CCE-98E7-482EDA3F8A35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6246" t="60453" r="71230" b="12621"/>
          <a:stretch/>
        </p:blipFill>
        <p:spPr>
          <a:xfrm>
            <a:off x="6080576" y="669295"/>
            <a:ext cx="1847808" cy="1656655"/>
          </a:xfrm>
          <a:prstGeom prst="rect">
            <a:avLst/>
          </a:prstGeom>
        </p:spPr>
      </p:pic>
      <p:pic>
        <p:nvPicPr>
          <p:cNvPr id="6" name="Picture 5">
            <a:extLst>
              <a:ext uri="{FF2B5EF4-FFF2-40B4-BE49-F238E27FC236}">
                <a16:creationId xmlns:a16="http://schemas.microsoft.com/office/drawing/2014/main" id="{4856175E-7B4F-4EA0-95B9-D6E9109123DD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38965" t="60065" r="37637" b="8608"/>
          <a:stretch/>
        </p:blipFill>
        <p:spPr>
          <a:xfrm>
            <a:off x="8015338" y="479392"/>
            <a:ext cx="1900812" cy="1908700"/>
          </a:xfrm>
          <a:prstGeom prst="rect">
            <a:avLst/>
          </a:prstGeom>
        </p:spPr>
      </p:pic>
      <p:pic>
        <p:nvPicPr>
          <p:cNvPr id="7" name="Picture 6">
            <a:extLst>
              <a:ext uri="{FF2B5EF4-FFF2-40B4-BE49-F238E27FC236}">
                <a16:creationId xmlns:a16="http://schemas.microsoft.com/office/drawing/2014/main" id="{CDBAF0D7-546F-4BA9-BBF4-F66893FC1DCC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72460" t="60065" r="6763" b="12104"/>
          <a:stretch/>
        </p:blipFill>
        <p:spPr>
          <a:xfrm>
            <a:off x="10003104" y="479392"/>
            <a:ext cx="1899822" cy="1908700"/>
          </a:xfrm>
          <a:prstGeom prst="rect">
            <a:avLst/>
          </a:prstGeom>
        </p:spPr>
      </p:pic>
      <p:pic>
        <p:nvPicPr>
          <p:cNvPr id="11" name="Picture 10">
            <a:extLst>
              <a:ext uri="{FF2B5EF4-FFF2-40B4-BE49-F238E27FC236}">
                <a16:creationId xmlns:a16="http://schemas.microsoft.com/office/drawing/2014/main" id="{615923C7-107A-46C8-87AB-8F208F28DF9A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149" t="65113" r="71133" b="8479"/>
          <a:stretch/>
        </p:blipFill>
        <p:spPr>
          <a:xfrm>
            <a:off x="2647372" y="3462107"/>
            <a:ext cx="1900811" cy="1862091"/>
          </a:xfrm>
          <a:prstGeom prst="rect">
            <a:avLst/>
          </a:prstGeom>
        </p:spPr>
      </p:pic>
      <p:pic>
        <p:nvPicPr>
          <p:cNvPr id="12" name="Picture 11">
            <a:extLst>
              <a:ext uri="{FF2B5EF4-FFF2-40B4-BE49-F238E27FC236}">
                <a16:creationId xmlns:a16="http://schemas.microsoft.com/office/drawing/2014/main" id="{2D8FDF8A-C1E7-4124-B22A-6ED5AE67A610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1197" t="59935" r="37929" b="14951"/>
          <a:stretch/>
        </p:blipFill>
        <p:spPr>
          <a:xfrm>
            <a:off x="5175788" y="3480529"/>
            <a:ext cx="1900811" cy="1862091"/>
          </a:xfrm>
          <a:prstGeom prst="rect">
            <a:avLst/>
          </a:prstGeom>
        </p:spPr>
      </p:pic>
      <p:pic>
        <p:nvPicPr>
          <p:cNvPr id="13" name="Picture 12">
            <a:extLst>
              <a:ext uri="{FF2B5EF4-FFF2-40B4-BE49-F238E27FC236}">
                <a16:creationId xmlns:a16="http://schemas.microsoft.com/office/drawing/2014/main" id="{C8D6F9F7-D6B1-4C94-8C10-7EB257E3ECCC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4401" t="61877" r="4336" b="11068"/>
          <a:stretch/>
        </p:blipFill>
        <p:spPr>
          <a:xfrm>
            <a:off x="7643819" y="3429000"/>
            <a:ext cx="1944210" cy="1855433"/>
          </a:xfrm>
          <a:prstGeom prst="rect">
            <a:avLst/>
          </a:prstGeom>
        </p:spPr>
      </p:pic>
      <p:graphicFrame>
        <p:nvGraphicFramePr>
          <p:cNvPr id="14" name="Table 13">
            <a:extLst>
              <a:ext uri="{FF2B5EF4-FFF2-40B4-BE49-F238E27FC236}">
                <a16:creationId xmlns:a16="http://schemas.microsoft.com/office/drawing/2014/main" id="{E4FFDB64-9E13-463F-B8D5-EB041FD45004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9257559"/>
              </p:ext>
            </p:extLst>
          </p:nvPr>
        </p:nvGraphicFramePr>
        <p:xfrm>
          <a:off x="526154" y="2370337"/>
          <a:ext cx="1347988" cy="4343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47988">
                  <a:extLst>
                    <a:ext uri="{9D8B030D-6E8A-4147-A177-3AD203B41FA5}">
                      <a16:colId xmlns:a16="http://schemas.microsoft.com/office/drawing/2014/main" val="3216714563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 Black" panose="020B0A04020102020204" pitchFamily="34" charset="0"/>
                        </a:rPr>
                        <a:t>Zhongzhi33</a:t>
                      </a:r>
                    </a:p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Black" panose="020B0A04020102020204" pitchFamily="34" charset="0"/>
                        </a:rPr>
                        <a:t>(black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902306261"/>
                  </a:ext>
                </a:extLst>
              </a:tr>
            </a:tbl>
          </a:graphicData>
        </a:graphic>
      </p:graphicFrame>
      <p:graphicFrame>
        <p:nvGraphicFramePr>
          <p:cNvPr id="15" name="Table 14">
            <a:extLst>
              <a:ext uri="{FF2B5EF4-FFF2-40B4-BE49-F238E27FC236}">
                <a16:creationId xmlns:a16="http://schemas.microsoft.com/office/drawing/2014/main" id="{13829875-9331-4255-85A1-5252061C098F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385429988"/>
              </p:ext>
            </p:extLst>
          </p:nvPr>
        </p:nvGraphicFramePr>
        <p:xfrm>
          <a:off x="2594478" y="2388092"/>
          <a:ext cx="1003300" cy="4343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03300">
                  <a:extLst>
                    <a:ext uri="{9D8B030D-6E8A-4147-A177-3AD203B41FA5}">
                      <a16:colId xmlns:a16="http://schemas.microsoft.com/office/drawing/2014/main" val="2128208672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 err="1">
                          <a:effectLst/>
                          <a:latin typeface="Arial Black" panose="020B0A04020102020204" pitchFamily="34" charset="0"/>
                        </a:rPr>
                        <a:t>Mishuo</a:t>
                      </a:r>
                      <a:endParaRPr lang="en-US" sz="1400" u="none" strike="noStrike" dirty="0">
                        <a:effectLst/>
                        <a:latin typeface="Arial Black" panose="020B0A04020102020204" pitchFamily="34" charset="0"/>
                      </a:endParaRP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Black" panose="020B0A04020102020204" pitchFamily="34" charset="0"/>
                        </a:rPr>
                        <a:t>(black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1114461808"/>
                  </a:ext>
                </a:extLst>
              </a:tr>
            </a:tbl>
          </a:graphicData>
        </a:graphic>
      </p:graphicFrame>
      <p:graphicFrame>
        <p:nvGraphicFramePr>
          <p:cNvPr id="16" name="Table 15">
            <a:extLst>
              <a:ext uri="{FF2B5EF4-FFF2-40B4-BE49-F238E27FC236}">
                <a16:creationId xmlns:a16="http://schemas.microsoft.com/office/drawing/2014/main" id="{AE42200C-7CE9-4D84-A088-B06463DF7A1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72176916"/>
              </p:ext>
            </p:extLst>
          </p:nvPr>
        </p:nvGraphicFramePr>
        <p:xfrm>
          <a:off x="4532149" y="2388092"/>
          <a:ext cx="1003300" cy="4343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003300">
                  <a:extLst>
                    <a:ext uri="{9D8B030D-6E8A-4147-A177-3AD203B41FA5}">
                      <a16:colId xmlns:a16="http://schemas.microsoft.com/office/drawing/2014/main" val="37411021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 Black" panose="020B0A04020102020204" pitchFamily="34" charset="0"/>
                        </a:rPr>
                        <a:t>WZ62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Black" panose="020B0A04020102020204" pitchFamily="34" charset="0"/>
                        </a:rPr>
                        <a:t>(black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8439896"/>
                  </a:ext>
                </a:extLst>
              </a:tr>
            </a:tbl>
          </a:graphicData>
        </a:graphic>
      </p:graphicFrame>
      <p:graphicFrame>
        <p:nvGraphicFramePr>
          <p:cNvPr id="19" name="Table 18">
            <a:extLst>
              <a:ext uri="{FF2B5EF4-FFF2-40B4-BE49-F238E27FC236}">
                <a16:creationId xmlns:a16="http://schemas.microsoft.com/office/drawing/2014/main" id="{F05AD697-73E5-4CB4-B78D-5D50988DD4E9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64864772"/>
              </p:ext>
            </p:extLst>
          </p:nvPr>
        </p:nvGraphicFramePr>
        <p:xfrm>
          <a:off x="10451364" y="2388092"/>
          <a:ext cx="1373692" cy="4343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73692">
                  <a:extLst>
                    <a:ext uri="{9D8B030D-6E8A-4147-A177-3AD203B41FA5}">
                      <a16:colId xmlns:a16="http://schemas.microsoft.com/office/drawing/2014/main" val="37411021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 Black" panose="020B0A04020102020204" pitchFamily="34" charset="0"/>
                        </a:rPr>
                        <a:t>G135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Black" panose="020B0A04020102020204" pitchFamily="34" charset="0"/>
                        </a:rPr>
                        <a:t>(brown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8439896"/>
                  </a:ext>
                </a:extLst>
              </a:tr>
            </a:tbl>
          </a:graphicData>
        </a:graphic>
      </p:graphicFrame>
      <p:graphicFrame>
        <p:nvGraphicFramePr>
          <p:cNvPr id="20" name="Table 19">
            <a:extLst>
              <a:ext uri="{FF2B5EF4-FFF2-40B4-BE49-F238E27FC236}">
                <a16:creationId xmlns:a16="http://schemas.microsoft.com/office/drawing/2014/main" id="{21155ECE-80EA-4BB2-8E51-349C242FE027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02998782"/>
              </p:ext>
            </p:extLst>
          </p:nvPr>
        </p:nvGraphicFramePr>
        <p:xfrm>
          <a:off x="8463375" y="2388092"/>
          <a:ext cx="1267929" cy="4343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67929">
                  <a:extLst>
                    <a:ext uri="{9D8B030D-6E8A-4147-A177-3AD203B41FA5}">
                      <a16:colId xmlns:a16="http://schemas.microsoft.com/office/drawing/2014/main" val="37411021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 Black" panose="020B0A04020102020204" pitchFamily="34" charset="0"/>
                        </a:rPr>
                        <a:t>G212</a:t>
                      </a:r>
                    </a:p>
                    <a:p>
                      <a:pPr marL="0" marR="0" lvl="0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Black" panose="020B0A04020102020204" pitchFamily="34" charset="0"/>
                        </a:rPr>
                        <a:t>(brown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8439896"/>
                  </a:ext>
                </a:extLst>
              </a:tr>
            </a:tbl>
          </a:graphicData>
        </a:graphic>
      </p:graphicFrame>
      <p:graphicFrame>
        <p:nvGraphicFramePr>
          <p:cNvPr id="21" name="Table 20">
            <a:extLst>
              <a:ext uri="{FF2B5EF4-FFF2-40B4-BE49-F238E27FC236}">
                <a16:creationId xmlns:a16="http://schemas.microsoft.com/office/drawing/2014/main" id="{9799EB55-14D1-464C-A6D1-4FFB66358CED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529979408"/>
              </p:ext>
            </p:extLst>
          </p:nvPr>
        </p:nvGraphicFramePr>
        <p:xfrm>
          <a:off x="6469820" y="2365380"/>
          <a:ext cx="1326850" cy="4343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26850">
                  <a:extLst>
                    <a:ext uri="{9D8B030D-6E8A-4147-A177-3AD203B41FA5}">
                      <a16:colId xmlns:a16="http://schemas.microsoft.com/office/drawing/2014/main" val="37411021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u="none" strike="noStrike" dirty="0">
                          <a:effectLst/>
                          <a:latin typeface="Arial Black" panose="020B0A04020102020204" pitchFamily="34" charset="0"/>
                        </a:rPr>
                        <a:t>G063</a:t>
                      </a:r>
                    </a:p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Black" panose="020B0A04020102020204" pitchFamily="34" charset="0"/>
                        </a:rPr>
                        <a:t>(brown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8439896"/>
                  </a:ext>
                </a:extLst>
              </a:tr>
            </a:tbl>
          </a:graphicData>
        </a:graphic>
      </p:graphicFrame>
      <p:graphicFrame>
        <p:nvGraphicFramePr>
          <p:cNvPr id="24" name="Table 23">
            <a:extLst>
              <a:ext uri="{FF2B5EF4-FFF2-40B4-BE49-F238E27FC236}">
                <a16:creationId xmlns:a16="http://schemas.microsoft.com/office/drawing/2014/main" id="{2CD92B40-78E5-4C2F-9952-013DF7392E5C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67249698"/>
              </p:ext>
            </p:extLst>
          </p:nvPr>
        </p:nvGraphicFramePr>
        <p:xfrm>
          <a:off x="5439698" y="5426439"/>
          <a:ext cx="1372990" cy="4343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372990">
                  <a:extLst>
                    <a:ext uri="{9D8B030D-6E8A-4147-A177-3AD203B41FA5}">
                      <a16:colId xmlns:a16="http://schemas.microsoft.com/office/drawing/2014/main" val="37411021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Black" panose="020B0A04020102020204" pitchFamily="34" charset="0"/>
                        </a:rPr>
                        <a:t>ZM38</a:t>
                      </a:r>
                    </a:p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Black" panose="020B0A04020102020204" pitchFamily="34" charset="0"/>
                        </a:rPr>
                        <a:t>(White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8439896"/>
                  </a:ext>
                </a:extLst>
              </a:tr>
            </a:tbl>
          </a:graphicData>
        </a:graphic>
      </p:graphicFrame>
      <p:graphicFrame>
        <p:nvGraphicFramePr>
          <p:cNvPr id="25" name="Table 24">
            <a:extLst>
              <a:ext uri="{FF2B5EF4-FFF2-40B4-BE49-F238E27FC236}">
                <a16:creationId xmlns:a16="http://schemas.microsoft.com/office/drawing/2014/main" id="{B2F0516C-8702-4209-86E8-4CF1CC65F6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58517091"/>
              </p:ext>
            </p:extLst>
          </p:nvPr>
        </p:nvGraphicFramePr>
        <p:xfrm>
          <a:off x="3344600" y="5428176"/>
          <a:ext cx="1273302" cy="4343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73302">
                  <a:extLst>
                    <a:ext uri="{9D8B030D-6E8A-4147-A177-3AD203B41FA5}">
                      <a16:colId xmlns:a16="http://schemas.microsoft.com/office/drawing/2014/main" val="37411021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Black" panose="020B0A04020102020204" pitchFamily="34" charset="0"/>
                        </a:rPr>
                        <a:t>Zhongzhi28</a:t>
                      </a:r>
                    </a:p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Black" panose="020B0A04020102020204" pitchFamily="34" charset="0"/>
                        </a:rPr>
                        <a:t>(White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8439896"/>
                  </a:ext>
                </a:extLst>
              </a:tr>
            </a:tbl>
          </a:graphicData>
        </a:graphic>
      </p:graphicFrame>
      <p:graphicFrame>
        <p:nvGraphicFramePr>
          <p:cNvPr id="26" name="Table 25">
            <a:extLst>
              <a:ext uri="{FF2B5EF4-FFF2-40B4-BE49-F238E27FC236}">
                <a16:creationId xmlns:a16="http://schemas.microsoft.com/office/drawing/2014/main" id="{3448777C-335C-494C-892A-1605E06BE3F8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950352536"/>
              </p:ext>
            </p:extLst>
          </p:nvPr>
        </p:nvGraphicFramePr>
        <p:xfrm>
          <a:off x="8138999" y="5426439"/>
          <a:ext cx="1292249" cy="43434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1292249">
                  <a:extLst>
                    <a:ext uri="{9D8B030D-6E8A-4147-A177-3AD203B41FA5}">
                      <a16:colId xmlns:a16="http://schemas.microsoft.com/office/drawing/2014/main" val="374110218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Black" panose="020B0A04020102020204" pitchFamily="34" charset="0"/>
                        </a:rPr>
                        <a:t>Zhongzhi13</a:t>
                      </a:r>
                    </a:p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Arial Black" panose="020B0A04020102020204" pitchFamily="34" charset="0"/>
                        </a:rPr>
                        <a:t>(White)</a:t>
                      </a:r>
                    </a:p>
                  </a:txBody>
                  <a:tcPr marL="7620" marR="7620" marT="7620" marB="0" anchor="ctr">
                    <a:noFill/>
                  </a:tcPr>
                </a:tc>
                <a:extLst>
                  <a:ext uri="{0D108BD9-81ED-4DB2-BD59-A6C34878D82A}">
                    <a16:rowId xmlns:a16="http://schemas.microsoft.com/office/drawing/2014/main" val="3958439896"/>
                  </a:ext>
                </a:extLst>
              </a:tr>
            </a:tbl>
          </a:graphicData>
        </a:graphic>
      </p:graphicFrame>
      <p:sp>
        <p:nvSpPr>
          <p:cNvPr id="17" name="TextBox 16">
            <a:extLst>
              <a:ext uri="{FF2B5EF4-FFF2-40B4-BE49-F238E27FC236}">
                <a16:creationId xmlns:a16="http://schemas.microsoft.com/office/drawing/2014/main" id="{D173436B-38AD-419D-ACB7-2D941B9BF2DC}"/>
              </a:ext>
            </a:extLst>
          </p:cNvPr>
          <p:cNvSpPr txBox="1"/>
          <p:nvPr/>
        </p:nvSpPr>
        <p:spPr>
          <a:xfrm>
            <a:off x="3140390" y="6181488"/>
            <a:ext cx="570646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>
                <a:latin typeface="Arial Black" panose="020B0A04020102020204" pitchFamily="34" charset="0"/>
              </a:rPr>
              <a:t>Figure S1</a:t>
            </a:r>
            <a:r>
              <a:rPr lang="en-US" sz="2400" dirty="0">
                <a:latin typeface="Arial Black" panose="020B0A04020102020204" pitchFamily="34" charset="0"/>
              </a:rPr>
              <a:t>. </a:t>
            </a:r>
            <a:r>
              <a:rPr lang="en-US" sz="1600" dirty="0">
                <a:latin typeface="Arial Narrow" panose="020B0606020202030204" pitchFamily="34" charset="0"/>
              </a:rPr>
              <a:t>Phenotypes of the sesame varieties used in this study.</a:t>
            </a:r>
            <a:endParaRPr lang="en-US" sz="2400" dirty="0">
              <a:latin typeface="Arial Narrow" panose="020B060602020203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138023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77</TotalTime>
  <Words>49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Arial Black</vt:lpstr>
      <vt:lpstr>Arial Narrow</vt:lpstr>
      <vt:lpstr>Calibri</vt:lpstr>
      <vt:lpstr>Calibri Light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nouwa Segla Koffi Dossou</dc:creator>
  <cp:lastModifiedBy>Senouwa Segla Koffi Dossou</cp:lastModifiedBy>
  <cp:revision>18</cp:revision>
  <dcterms:created xsi:type="dcterms:W3CDTF">2021-08-23T02:46:28Z</dcterms:created>
  <dcterms:modified xsi:type="dcterms:W3CDTF">2022-01-13T08:56:26Z</dcterms:modified>
</cp:coreProperties>
</file>